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62" r:id="rId2"/>
    <p:sldId id="269" r:id="rId3"/>
    <p:sldId id="263" r:id="rId4"/>
    <p:sldId id="268" r:id="rId5"/>
  </p:sldIdLst>
  <p:sldSz cx="6858000" cy="9906000" type="A4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sm" initials="l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FF33"/>
    <a:srgbClr val="E6E6E6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726" autoAdjust="0"/>
    <p:restoredTop sz="96433" autoAdjust="0"/>
  </p:normalViewPr>
  <p:slideViewPr>
    <p:cSldViewPr snapToGrid="0">
      <p:cViewPr>
        <p:scale>
          <a:sx n="118" d="100"/>
          <a:sy n="118" d="100"/>
        </p:scale>
        <p:origin x="216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1!$B$1:$C$1</c:f>
              <c:strCache>
                <c:ptCount val="2"/>
                <c:pt idx="0">
                  <c:v>cave</c:v>
                </c:pt>
                <c:pt idx="1">
                  <c:v>surface</c:v>
                </c:pt>
              </c:strCache>
            </c:strRef>
          </c:cat>
          <c:val>
            <c:numRef>
              <c:f>Sheet1!$B$2:$C$2</c:f>
              <c:numCache>
                <c:formatCode>General</c:formatCode>
                <c:ptCount val="2"/>
                <c:pt idx="0">
                  <c:v>2</c:v>
                </c:pt>
                <c:pt idx="1">
                  <c:v>1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07C-4C97-9B20-6FEF104BDC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64310384"/>
        <c:axId val="464311216"/>
      </c:barChart>
      <c:catAx>
        <c:axId val="4643103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464311216"/>
        <c:crosses val="autoZero"/>
        <c:auto val="1"/>
        <c:lblAlgn val="ctr"/>
        <c:lblOffset val="100"/>
        <c:noMultiLvlLbl val="0"/>
      </c:catAx>
      <c:valAx>
        <c:axId val="4643112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 smtClean="0"/>
                  <a:t>Number of ramming attacks in 1 h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4643103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375" y="1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EDDCD1-FD79-4B55-B767-0BBF12BD5174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35238" y="1200150"/>
            <a:ext cx="224472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838" y="4621214"/>
            <a:ext cx="5851525" cy="37798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375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7DF37A9-7708-449F-B3A4-1D015F5FFA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0592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10A5F-1C24-4FCB-B65E-99F51457305B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0FA97-A165-476D-8FCD-582432449B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10A5F-1C24-4FCB-B65E-99F51457305B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0FA97-A165-476D-8FCD-582432449B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10A5F-1C24-4FCB-B65E-99F51457305B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0FA97-A165-476D-8FCD-582432449B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10A5F-1C24-4FCB-B65E-99F51457305B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0FA97-A165-476D-8FCD-582432449B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10A5F-1C24-4FCB-B65E-99F51457305B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0FA97-A165-476D-8FCD-582432449B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10A5F-1C24-4FCB-B65E-99F51457305B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0FA97-A165-476D-8FCD-582432449B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10A5F-1C24-4FCB-B65E-99F51457305B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0FA97-A165-476D-8FCD-582432449B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10A5F-1C24-4FCB-B65E-99F51457305B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0FA97-A165-476D-8FCD-582432449B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10A5F-1C24-4FCB-B65E-99F51457305B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0FA97-A165-476D-8FCD-582432449B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10A5F-1C24-4FCB-B65E-99F51457305B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0FA97-A165-476D-8FCD-582432449B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10A5F-1C24-4FCB-B65E-99F51457305B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0FA97-A165-476D-8FCD-582432449B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F10A5F-1C24-4FCB-B65E-99F51457305B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E0FA97-A165-476D-8FCD-582432449B58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tiff"/><Relationship Id="rId3" Type="http://schemas.openxmlformats.org/officeDocument/2006/relationships/image" Target="../media/image6.tiff"/><Relationship Id="rId7" Type="http://schemas.openxmlformats.org/officeDocument/2006/relationships/image" Target="../media/image10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tiff"/><Relationship Id="rId5" Type="http://schemas.openxmlformats.org/officeDocument/2006/relationships/image" Target="../media/image8.tiff"/><Relationship Id="rId4" Type="http://schemas.openxmlformats.org/officeDocument/2006/relationships/image" Target="../media/image7.tiff"/><Relationship Id="rId9" Type="http://schemas.openxmlformats.org/officeDocument/2006/relationships/image" Target="../media/image12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4.png"/><Relationship Id="rId7" Type="http://schemas.openxmlformats.org/officeDocument/2006/relationships/image" Target="../media/image17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5" Type="http://schemas.openxmlformats.org/officeDocument/2006/relationships/chart" Target="../charts/chart1.xml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68142"/>
            <a:ext cx="6858000" cy="493119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" y="21921"/>
            <a:ext cx="21041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4142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Group 52"/>
          <p:cNvGrpSpPr/>
          <p:nvPr/>
        </p:nvGrpSpPr>
        <p:grpSpPr>
          <a:xfrm>
            <a:off x="367508" y="511956"/>
            <a:ext cx="5854825" cy="5653282"/>
            <a:chOff x="472611" y="785224"/>
            <a:chExt cx="5854825" cy="5653282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70845" y="785224"/>
              <a:ext cx="2856591" cy="2698727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72611" y="785224"/>
              <a:ext cx="2871626" cy="2751348"/>
            </a:xfrm>
            <a:prstGeom prst="rect">
              <a:avLst/>
            </a:prstGeom>
          </p:spPr>
        </p:pic>
        <p:grpSp>
          <p:nvGrpSpPr>
            <p:cNvPr id="14" name="Group 13"/>
            <p:cNvGrpSpPr/>
            <p:nvPr/>
          </p:nvGrpSpPr>
          <p:grpSpPr>
            <a:xfrm>
              <a:off x="1435433" y="1850128"/>
              <a:ext cx="1140911" cy="65542"/>
              <a:chOff x="-1107583" y="2620851"/>
              <a:chExt cx="779258" cy="154546"/>
            </a:xfrm>
          </p:grpSpPr>
          <p:cxnSp>
            <p:nvCxnSpPr>
              <p:cNvPr id="15" name="Straight Connector 14"/>
              <p:cNvCxnSpPr/>
              <p:nvPr/>
            </p:nvCxnSpPr>
            <p:spPr>
              <a:xfrm>
                <a:off x="-1107583" y="2620851"/>
                <a:ext cx="0" cy="15454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/>
              <p:cNvCxnSpPr/>
              <p:nvPr/>
            </p:nvCxnSpPr>
            <p:spPr>
              <a:xfrm>
                <a:off x="-1107583" y="2620851"/>
                <a:ext cx="77917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/>
              <p:cNvCxnSpPr/>
              <p:nvPr/>
            </p:nvCxnSpPr>
            <p:spPr>
              <a:xfrm>
                <a:off x="-328325" y="2620851"/>
                <a:ext cx="0" cy="15454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" name="Group 17"/>
            <p:cNvGrpSpPr/>
            <p:nvPr/>
          </p:nvGrpSpPr>
          <p:grpSpPr>
            <a:xfrm>
              <a:off x="1714063" y="1574576"/>
              <a:ext cx="1140911" cy="65542"/>
              <a:chOff x="-1107583" y="2620851"/>
              <a:chExt cx="779258" cy="154546"/>
            </a:xfrm>
          </p:grpSpPr>
          <p:cxnSp>
            <p:nvCxnSpPr>
              <p:cNvPr id="19" name="Straight Connector 18"/>
              <p:cNvCxnSpPr/>
              <p:nvPr/>
            </p:nvCxnSpPr>
            <p:spPr>
              <a:xfrm>
                <a:off x="-1107583" y="2620851"/>
                <a:ext cx="0" cy="15454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/>
              <p:cNvCxnSpPr/>
              <p:nvPr/>
            </p:nvCxnSpPr>
            <p:spPr>
              <a:xfrm>
                <a:off x="-1107583" y="2620851"/>
                <a:ext cx="77917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/>
              <p:cNvCxnSpPr/>
              <p:nvPr/>
            </p:nvCxnSpPr>
            <p:spPr>
              <a:xfrm>
                <a:off x="-328325" y="2620851"/>
                <a:ext cx="0" cy="15454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" name="Group 21"/>
            <p:cNvGrpSpPr/>
            <p:nvPr/>
          </p:nvGrpSpPr>
          <p:grpSpPr>
            <a:xfrm>
              <a:off x="4481412" y="1979661"/>
              <a:ext cx="1075799" cy="69936"/>
              <a:chOff x="-1107583" y="2620851"/>
              <a:chExt cx="779258" cy="154546"/>
            </a:xfrm>
          </p:grpSpPr>
          <p:cxnSp>
            <p:nvCxnSpPr>
              <p:cNvPr id="23" name="Straight Connector 22"/>
              <p:cNvCxnSpPr/>
              <p:nvPr/>
            </p:nvCxnSpPr>
            <p:spPr>
              <a:xfrm>
                <a:off x="-1107583" y="2620851"/>
                <a:ext cx="0" cy="15454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" name="Straight Connector 23"/>
              <p:cNvCxnSpPr/>
              <p:nvPr/>
            </p:nvCxnSpPr>
            <p:spPr>
              <a:xfrm>
                <a:off x="-1107583" y="2620851"/>
                <a:ext cx="77917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Straight Connector 24"/>
              <p:cNvCxnSpPr/>
              <p:nvPr/>
            </p:nvCxnSpPr>
            <p:spPr>
              <a:xfrm>
                <a:off x="-328325" y="2620851"/>
                <a:ext cx="0" cy="15454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 25"/>
            <p:cNvGrpSpPr/>
            <p:nvPr/>
          </p:nvGrpSpPr>
          <p:grpSpPr>
            <a:xfrm>
              <a:off x="4756964" y="1607347"/>
              <a:ext cx="1075799" cy="69936"/>
              <a:chOff x="-1107583" y="2620851"/>
              <a:chExt cx="779258" cy="154546"/>
            </a:xfrm>
          </p:grpSpPr>
          <p:cxnSp>
            <p:nvCxnSpPr>
              <p:cNvPr id="27" name="Straight Connector 26"/>
              <p:cNvCxnSpPr/>
              <p:nvPr/>
            </p:nvCxnSpPr>
            <p:spPr>
              <a:xfrm>
                <a:off x="-1107583" y="2620851"/>
                <a:ext cx="0" cy="15454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>
                <a:off x="-1107583" y="2620851"/>
                <a:ext cx="77917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>
                <a:off x="-328325" y="2620851"/>
                <a:ext cx="0" cy="15454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08823" y="3657088"/>
              <a:ext cx="2871626" cy="2781418"/>
            </a:xfrm>
            <a:prstGeom prst="rect">
              <a:avLst/>
            </a:prstGeom>
          </p:spPr>
        </p:pic>
        <p:grpSp>
          <p:nvGrpSpPr>
            <p:cNvPr id="38" name="Group 37"/>
            <p:cNvGrpSpPr/>
            <p:nvPr/>
          </p:nvGrpSpPr>
          <p:grpSpPr>
            <a:xfrm>
              <a:off x="1437167" y="4550432"/>
              <a:ext cx="1183379" cy="69936"/>
              <a:chOff x="-1107583" y="2620851"/>
              <a:chExt cx="779258" cy="154546"/>
            </a:xfrm>
          </p:grpSpPr>
          <p:cxnSp>
            <p:nvCxnSpPr>
              <p:cNvPr id="39" name="Straight Connector 38"/>
              <p:cNvCxnSpPr/>
              <p:nvPr/>
            </p:nvCxnSpPr>
            <p:spPr>
              <a:xfrm>
                <a:off x="-1107583" y="2620851"/>
                <a:ext cx="0" cy="15454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/>
              <p:cNvCxnSpPr/>
              <p:nvPr/>
            </p:nvCxnSpPr>
            <p:spPr>
              <a:xfrm>
                <a:off x="-1107583" y="2620851"/>
                <a:ext cx="77917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" name="Straight Connector 40"/>
              <p:cNvCxnSpPr/>
              <p:nvPr/>
            </p:nvCxnSpPr>
            <p:spPr>
              <a:xfrm>
                <a:off x="-328325" y="2620851"/>
                <a:ext cx="0" cy="15454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2" name="Group 41"/>
            <p:cNvGrpSpPr/>
            <p:nvPr/>
          </p:nvGrpSpPr>
          <p:grpSpPr>
            <a:xfrm>
              <a:off x="1727814" y="4240977"/>
              <a:ext cx="1183379" cy="69936"/>
              <a:chOff x="-1107583" y="2620851"/>
              <a:chExt cx="779258" cy="154546"/>
            </a:xfrm>
          </p:grpSpPr>
          <p:cxnSp>
            <p:nvCxnSpPr>
              <p:cNvPr id="43" name="Straight Connector 42"/>
              <p:cNvCxnSpPr/>
              <p:nvPr/>
            </p:nvCxnSpPr>
            <p:spPr>
              <a:xfrm>
                <a:off x="-1107583" y="2620851"/>
                <a:ext cx="0" cy="15454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/>
              <p:cNvCxnSpPr/>
              <p:nvPr/>
            </p:nvCxnSpPr>
            <p:spPr>
              <a:xfrm>
                <a:off x="-1107583" y="2620851"/>
                <a:ext cx="77917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/>
              <p:cNvCxnSpPr/>
              <p:nvPr/>
            </p:nvCxnSpPr>
            <p:spPr>
              <a:xfrm>
                <a:off x="-328325" y="2620851"/>
                <a:ext cx="0" cy="15454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7" name="TextBox 46"/>
            <p:cNvSpPr txBox="1"/>
            <p:nvPr/>
          </p:nvSpPr>
          <p:spPr>
            <a:xfrm>
              <a:off x="1678937" y="1645218"/>
              <a:ext cx="80546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eO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P&lt;0.05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1921292" y="1388465"/>
              <a:ext cx="90649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C P&lt;0.05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624414" y="1781455"/>
              <a:ext cx="80546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eO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P&lt;0.1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935358" y="1421996"/>
              <a:ext cx="90649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C P&lt;0.05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643787" y="4362427"/>
              <a:ext cx="80546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eO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P&lt;0.1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1908424" y="4061380"/>
              <a:ext cx="90649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C P&lt;0.05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4" name="TextBox 53"/>
          <p:cNvSpPr txBox="1"/>
          <p:nvPr/>
        </p:nvSpPr>
        <p:spPr>
          <a:xfrm>
            <a:off x="1" y="21921"/>
            <a:ext cx="21041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96325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extBox 55"/>
          <p:cNvSpPr txBox="1"/>
          <p:nvPr/>
        </p:nvSpPr>
        <p:spPr>
          <a:xfrm>
            <a:off x="1" y="21921"/>
            <a:ext cx="21041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94361" y="490078"/>
            <a:ext cx="6606847" cy="3855719"/>
            <a:chOff x="194361" y="490078"/>
            <a:chExt cx="6606847" cy="3855719"/>
          </a:xfrm>
        </p:grpSpPr>
        <p:sp>
          <p:nvSpPr>
            <p:cNvPr id="40" name="Rectangle 39"/>
            <p:cNvSpPr/>
            <p:nvPr/>
          </p:nvSpPr>
          <p:spPr>
            <a:xfrm>
              <a:off x="199771" y="490078"/>
              <a:ext cx="6498367" cy="1789659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199771" y="490078"/>
              <a:ext cx="5482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5774325" y="511351"/>
              <a:ext cx="1026883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solidFill>
                    <a:srgbClr val="0066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lue: DAPI</a:t>
              </a:r>
            </a:p>
            <a:p>
              <a:r>
                <a:rPr lang="en-US" sz="11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d: MBP</a:t>
              </a:r>
              <a:endParaRPr lang="en-US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5944416" y="1455942"/>
              <a:ext cx="5422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O</a:t>
              </a:r>
              <a:endParaRPr lang="en-US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4" name="图片 22">
              <a:extLst>
                <a:ext uri="{FF2B5EF4-FFF2-40B4-BE49-F238E27FC236}">
                  <a16:creationId xmlns:a16="http://schemas.microsoft.com/office/drawing/2014/main" id="{9142A7F9-AC3B-453F-B3A8-21D2740598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4528"/>
            <a:stretch/>
          </p:blipFill>
          <p:spPr>
            <a:xfrm>
              <a:off x="489021" y="540239"/>
              <a:ext cx="1079906" cy="1068681"/>
            </a:xfrm>
            <a:prstGeom prst="rect">
              <a:avLst/>
            </a:prstGeom>
          </p:spPr>
        </p:pic>
        <p:pic>
          <p:nvPicPr>
            <p:cNvPr id="45" name="图片 28">
              <a:extLst>
                <a:ext uri="{FF2B5EF4-FFF2-40B4-BE49-F238E27FC236}">
                  <a16:creationId xmlns:a16="http://schemas.microsoft.com/office/drawing/2014/main" id="{8BA0CC64-B21A-4884-97C2-3ABEF02E49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4462"/>
            <a:stretch/>
          </p:blipFill>
          <p:spPr>
            <a:xfrm>
              <a:off x="1937166" y="1135006"/>
              <a:ext cx="1014839" cy="967212"/>
            </a:xfrm>
            <a:prstGeom prst="rect">
              <a:avLst/>
            </a:prstGeom>
          </p:spPr>
        </p:pic>
        <p:sp>
          <p:nvSpPr>
            <p:cNvPr id="46" name="Rectangle 45"/>
            <p:cNvSpPr/>
            <p:nvPr/>
          </p:nvSpPr>
          <p:spPr>
            <a:xfrm>
              <a:off x="1927750" y="1119918"/>
              <a:ext cx="1024255" cy="982299"/>
            </a:xfrm>
            <a:prstGeom prst="rect">
              <a:avLst/>
            </a:prstGeom>
            <a:noFill/>
            <a:ln w="3175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Rectangle 46"/>
            <p:cNvSpPr/>
            <p:nvPr/>
          </p:nvSpPr>
          <p:spPr>
            <a:xfrm>
              <a:off x="1093144" y="1033833"/>
              <a:ext cx="173658" cy="156188"/>
            </a:xfrm>
            <a:prstGeom prst="rect">
              <a:avLst/>
            </a:prstGeom>
            <a:noFill/>
            <a:ln w="3175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8" name="Straight Connector 47"/>
            <p:cNvCxnSpPr/>
            <p:nvPr/>
          </p:nvCxnSpPr>
          <p:spPr>
            <a:xfrm>
              <a:off x="1090016" y="1192296"/>
              <a:ext cx="837734" cy="915182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>
              <a:off x="1266802" y="1027400"/>
              <a:ext cx="660948" cy="96303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0" name="图片 20">
              <a:extLst>
                <a:ext uri="{FF2B5EF4-FFF2-40B4-BE49-F238E27FC236}">
                  <a16:creationId xmlns:a16="http://schemas.microsoft.com/office/drawing/2014/main" id="{B93D0D4C-8C46-444E-8B78-FEF58EBC2F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728" r="45076"/>
            <a:stretch/>
          </p:blipFill>
          <p:spPr>
            <a:xfrm>
              <a:off x="3206052" y="541029"/>
              <a:ext cx="1253946" cy="1081233"/>
            </a:xfrm>
            <a:prstGeom prst="rect">
              <a:avLst/>
            </a:prstGeom>
          </p:spPr>
        </p:pic>
        <p:pic>
          <p:nvPicPr>
            <p:cNvPr id="51" name="图片 31">
              <a:extLst>
                <a:ext uri="{FF2B5EF4-FFF2-40B4-BE49-F238E27FC236}">
                  <a16:creationId xmlns:a16="http://schemas.microsoft.com/office/drawing/2014/main" id="{B85E92CC-5762-4F34-9B83-BE385162E17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4714"/>
            <a:stretch/>
          </p:blipFill>
          <p:spPr>
            <a:xfrm>
              <a:off x="4706921" y="1119919"/>
              <a:ext cx="1022351" cy="952762"/>
            </a:xfrm>
            <a:prstGeom prst="rect">
              <a:avLst/>
            </a:prstGeom>
          </p:spPr>
        </p:pic>
        <p:sp>
          <p:nvSpPr>
            <p:cNvPr id="52" name="Rectangle 51"/>
            <p:cNvSpPr/>
            <p:nvPr/>
          </p:nvSpPr>
          <p:spPr>
            <a:xfrm>
              <a:off x="4698946" y="1095597"/>
              <a:ext cx="1024255" cy="982299"/>
            </a:xfrm>
            <a:prstGeom prst="rect">
              <a:avLst/>
            </a:prstGeom>
            <a:noFill/>
            <a:ln w="3175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Rectangle 52"/>
            <p:cNvSpPr/>
            <p:nvPr/>
          </p:nvSpPr>
          <p:spPr>
            <a:xfrm>
              <a:off x="3855200" y="955546"/>
              <a:ext cx="173658" cy="179460"/>
            </a:xfrm>
            <a:prstGeom prst="rect">
              <a:avLst/>
            </a:prstGeom>
            <a:noFill/>
            <a:ln w="3175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4" name="Straight Connector 53"/>
            <p:cNvCxnSpPr/>
            <p:nvPr/>
          </p:nvCxnSpPr>
          <p:spPr>
            <a:xfrm>
              <a:off x="3855141" y="1134050"/>
              <a:ext cx="851780" cy="943846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>
              <a:off x="4043010" y="962308"/>
              <a:ext cx="663911" cy="139949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490970" y="1510890"/>
              <a:ext cx="5140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mm</a:t>
              </a:r>
              <a:endPara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249628" y="1502108"/>
              <a:ext cx="5140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mm</a:t>
              </a:r>
              <a:endPara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890297" y="1857237"/>
              <a:ext cx="7205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 µm</a:t>
              </a:r>
              <a:endPara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643398" y="1844155"/>
              <a:ext cx="7205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 µm</a:t>
              </a:r>
              <a:endPara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3" name="Group 22"/>
            <p:cNvGrpSpPr/>
            <p:nvPr/>
          </p:nvGrpSpPr>
          <p:grpSpPr>
            <a:xfrm>
              <a:off x="199771" y="2342454"/>
              <a:ext cx="6601437" cy="2003343"/>
              <a:chOff x="242623" y="1658111"/>
              <a:chExt cx="6601437" cy="2003343"/>
            </a:xfrm>
          </p:grpSpPr>
          <p:sp>
            <p:nvSpPr>
              <p:cNvPr id="28" name="Rectangle 27"/>
              <p:cNvSpPr/>
              <p:nvPr/>
            </p:nvSpPr>
            <p:spPr>
              <a:xfrm>
                <a:off x="242623" y="1658111"/>
                <a:ext cx="6498367" cy="2003343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5817177" y="1679384"/>
                <a:ext cx="1026883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 smtClean="0">
                    <a:solidFill>
                      <a:srgbClr val="0066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lue: DAPI</a:t>
                </a:r>
              </a:p>
              <a:p>
                <a:r>
                  <a:rPr lang="en-US" sz="1100" b="1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d: MBP</a:t>
                </a:r>
                <a:endParaRPr lang="en-US" sz="11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787264" y="3390765"/>
                <a:ext cx="77790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vefish</a:t>
                </a:r>
                <a:endPara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3600615" y="3399844"/>
                <a:ext cx="101459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urface fish</a:t>
                </a:r>
                <a:endPara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6012903" y="2786462"/>
                <a:ext cx="54221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C</a:t>
                </a:r>
                <a:endParaRPr 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3" name="图片 32">
                <a:extLst>
                  <a:ext uri="{FF2B5EF4-FFF2-40B4-BE49-F238E27FC236}">
                    <a16:creationId xmlns:a16="http://schemas.microsoft.com/office/drawing/2014/main" id="{8CD0927D-5225-4922-A5DF-F2B5CD7101F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6917" r="53752"/>
              <a:stretch/>
            </p:blipFill>
            <p:spPr>
              <a:xfrm>
                <a:off x="511337" y="1860501"/>
                <a:ext cx="876765" cy="864637"/>
              </a:xfrm>
              <a:prstGeom prst="rect">
                <a:avLst/>
              </a:prstGeom>
            </p:spPr>
          </p:pic>
          <p:pic>
            <p:nvPicPr>
              <p:cNvPr id="34" name="图片 37">
                <a:extLst>
                  <a:ext uri="{FF2B5EF4-FFF2-40B4-BE49-F238E27FC236}">
                    <a16:creationId xmlns:a16="http://schemas.microsoft.com/office/drawing/2014/main" id="{5D9C8ACE-2BF6-4660-A100-8A5F4192E29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43974"/>
              <a:stretch/>
            </p:blipFill>
            <p:spPr>
              <a:xfrm>
                <a:off x="1923995" y="2378830"/>
                <a:ext cx="1024255" cy="1003575"/>
              </a:xfrm>
              <a:prstGeom prst="rect">
                <a:avLst/>
              </a:prstGeom>
            </p:spPr>
          </p:pic>
          <p:sp>
            <p:nvSpPr>
              <p:cNvPr id="35" name="Rectangle 34"/>
              <p:cNvSpPr/>
              <p:nvPr/>
            </p:nvSpPr>
            <p:spPr>
              <a:xfrm>
                <a:off x="1933411" y="2367657"/>
                <a:ext cx="1014839" cy="1032187"/>
              </a:xfrm>
              <a:prstGeom prst="rect">
                <a:avLst/>
              </a:prstGeom>
              <a:noFill/>
              <a:ln w="3175"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948662" y="2222642"/>
                <a:ext cx="173658" cy="156188"/>
              </a:xfrm>
              <a:prstGeom prst="rect">
                <a:avLst/>
              </a:prstGeom>
              <a:noFill/>
              <a:ln w="3175"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37" name="Straight Connector 36"/>
              <p:cNvCxnSpPr/>
              <p:nvPr/>
            </p:nvCxnSpPr>
            <p:spPr>
              <a:xfrm>
                <a:off x="948662" y="2394131"/>
                <a:ext cx="984749" cy="1013432"/>
              </a:xfrm>
              <a:prstGeom prst="line">
                <a:avLst/>
              </a:prstGeom>
              <a:ln w="31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/>
              <p:cNvCxnSpPr/>
              <p:nvPr/>
            </p:nvCxnSpPr>
            <p:spPr>
              <a:xfrm>
                <a:off x="1122320" y="2218600"/>
                <a:ext cx="811091" cy="164358"/>
              </a:xfrm>
              <a:prstGeom prst="line">
                <a:avLst/>
              </a:prstGeom>
              <a:ln w="31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39" name="图片 7">
                <a:extLst>
                  <a:ext uri="{FF2B5EF4-FFF2-40B4-BE49-F238E27FC236}">
                    <a16:creationId xmlns:a16="http://schemas.microsoft.com/office/drawing/2014/main" id="{4411FDA0-9CA9-41EC-ACBC-244929703FE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1711" r="52602"/>
              <a:stretch/>
            </p:blipFill>
            <p:spPr>
              <a:xfrm>
                <a:off x="3246530" y="1711462"/>
                <a:ext cx="1078907" cy="978258"/>
              </a:xfrm>
              <a:prstGeom prst="rect">
                <a:avLst/>
              </a:prstGeom>
            </p:spPr>
          </p:pic>
          <p:pic>
            <p:nvPicPr>
              <p:cNvPr id="57" name="图片 15">
                <a:extLst>
                  <a:ext uri="{FF2B5EF4-FFF2-40B4-BE49-F238E27FC236}">
                    <a16:creationId xmlns:a16="http://schemas.microsoft.com/office/drawing/2014/main" id="{642174EC-6AD5-4DA2-90E2-3D23011125D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44381"/>
              <a:stretch/>
            </p:blipFill>
            <p:spPr>
              <a:xfrm>
                <a:off x="4687597" y="2397378"/>
                <a:ext cx="1053487" cy="1039778"/>
              </a:xfrm>
              <a:prstGeom prst="rect">
                <a:avLst/>
              </a:prstGeom>
            </p:spPr>
          </p:pic>
          <p:sp>
            <p:nvSpPr>
              <p:cNvPr id="58" name="Rectangle 57"/>
              <p:cNvSpPr/>
              <p:nvPr/>
            </p:nvSpPr>
            <p:spPr>
              <a:xfrm>
                <a:off x="4686959" y="2394401"/>
                <a:ext cx="1053858" cy="1056082"/>
              </a:xfrm>
              <a:prstGeom prst="rect">
                <a:avLst/>
              </a:prstGeom>
              <a:noFill/>
              <a:ln w="3175"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9" name="Rectangle 58"/>
              <p:cNvSpPr/>
              <p:nvPr/>
            </p:nvSpPr>
            <p:spPr>
              <a:xfrm>
                <a:off x="3917737" y="2151943"/>
                <a:ext cx="173658" cy="179460"/>
              </a:xfrm>
              <a:prstGeom prst="rect">
                <a:avLst/>
              </a:prstGeom>
              <a:noFill/>
              <a:ln w="3175"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60" name="Straight Connector 59"/>
              <p:cNvCxnSpPr/>
              <p:nvPr/>
            </p:nvCxnSpPr>
            <p:spPr>
              <a:xfrm>
                <a:off x="3917737" y="2324551"/>
                <a:ext cx="768955" cy="1140967"/>
              </a:xfrm>
              <a:prstGeom prst="line">
                <a:avLst/>
              </a:prstGeom>
              <a:ln w="31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60"/>
              <p:cNvCxnSpPr/>
              <p:nvPr/>
            </p:nvCxnSpPr>
            <p:spPr>
              <a:xfrm>
                <a:off x="4098691" y="2157999"/>
                <a:ext cx="588001" cy="236836"/>
              </a:xfrm>
              <a:prstGeom prst="line">
                <a:avLst/>
              </a:prstGeom>
              <a:ln w="31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2" name="TextBox 61"/>
            <p:cNvSpPr txBox="1"/>
            <p:nvPr/>
          </p:nvSpPr>
          <p:spPr>
            <a:xfrm>
              <a:off x="194361" y="2363727"/>
              <a:ext cx="5482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468218" y="3316016"/>
              <a:ext cx="5140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mm</a:t>
              </a:r>
              <a:endPara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245919" y="3289630"/>
              <a:ext cx="5140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mm</a:t>
              </a:r>
              <a:endPara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1830967" y="3834897"/>
              <a:ext cx="6127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 µm</a:t>
              </a:r>
              <a:endPara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4607690" y="3877832"/>
              <a:ext cx="6127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 µm</a:t>
              </a:r>
              <a:endPara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219132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" y="21921"/>
            <a:ext cx="21041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Group 16"/>
          <p:cNvGrpSpPr/>
          <p:nvPr/>
        </p:nvGrpSpPr>
        <p:grpSpPr>
          <a:xfrm>
            <a:off x="153100" y="464529"/>
            <a:ext cx="6323900" cy="2773972"/>
            <a:chOff x="153100" y="464529"/>
            <a:chExt cx="6323900" cy="2773972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/>
            <a:srcRect l="20755" t="29780" r="23154" b="22879"/>
            <a:stretch/>
          </p:blipFill>
          <p:spPr>
            <a:xfrm>
              <a:off x="198315" y="493150"/>
              <a:ext cx="1789480" cy="1318095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/>
            <a:srcRect l="13333" t="11317" r="12857" b="23475"/>
            <a:stretch/>
          </p:blipFill>
          <p:spPr>
            <a:xfrm>
              <a:off x="2033010" y="493149"/>
              <a:ext cx="1599190" cy="1318095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4"/>
            <a:srcRect l="17182" t="17011" r="14761" b="6548"/>
            <a:stretch/>
          </p:blipFill>
          <p:spPr>
            <a:xfrm>
              <a:off x="2589025" y="1839866"/>
              <a:ext cx="1043175" cy="1233533"/>
            </a:xfrm>
            <a:prstGeom prst="rect">
              <a:avLst/>
            </a:prstGeom>
          </p:spPr>
        </p:pic>
        <p:graphicFrame>
          <p:nvGraphicFramePr>
            <p:cNvPr id="9" name="Chart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77989331"/>
                </p:ext>
              </p:extLst>
            </p:nvPr>
          </p:nvGraphicFramePr>
          <p:xfrm>
            <a:off x="3836580" y="736367"/>
            <a:ext cx="2640420" cy="250213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0" name="TextBox 9"/>
            <p:cNvSpPr txBox="1"/>
            <p:nvPr/>
          </p:nvSpPr>
          <p:spPr>
            <a:xfrm>
              <a:off x="4824354" y="2707670"/>
              <a:ext cx="20703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679011" y="921364"/>
              <a:ext cx="4456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7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53100" y="464529"/>
              <a:ext cx="5482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836580" y="474757"/>
              <a:ext cx="5482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403474" y="1839865"/>
              <a:ext cx="1145173" cy="1233534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98315" y="1839866"/>
              <a:ext cx="1161230" cy="1233533"/>
            </a:xfrm>
            <a:prstGeom prst="rect">
              <a:avLst/>
            </a:prstGeom>
          </p:spPr>
        </p:pic>
      </p:grpSp>
      <p:pic>
        <p:nvPicPr>
          <p:cNvPr id="18" name="Picture 17"/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1503" y="1411575"/>
            <a:ext cx="819482" cy="799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76467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09</TotalTime>
  <Words>70</Words>
  <Application>Microsoft Office PowerPoint</Application>
  <PresentationFormat>A4 纸张(210x297 毫米)</PresentationFormat>
  <Paragraphs>33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sm</dc:creator>
  <cp:lastModifiedBy>税光厚</cp:lastModifiedBy>
  <cp:revision>160</cp:revision>
  <cp:lastPrinted>2022-01-28T14:37:55Z</cp:lastPrinted>
  <dcterms:created xsi:type="dcterms:W3CDTF">2021-10-02T05:08:00Z</dcterms:created>
  <dcterms:modified xsi:type="dcterms:W3CDTF">2022-03-01T23:45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F3039C48D2243D18C2603DA29C40D4D</vt:lpwstr>
  </property>
  <property fmtid="{D5CDD505-2E9C-101B-9397-08002B2CF9AE}" pid="3" name="KSOProductBuildVer">
    <vt:lpwstr>2052-11.1.0.10938</vt:lpwstr>
  </property>
</Properties>
</file>